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174D48-B6B3-4E90-905B-34FB3918AB7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60D6BD-AC9A-4B51-8EC5-4EE1ACC2E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4809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206153-1A6D-46AD-9E56-C8F0EBB7277B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CD1143-941C-463C-892A-006404F24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456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497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01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362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13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301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24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828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625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40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0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60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C6797-756E-4867-A7D1-4496BCF2CAAD}" type="datetimeFigureOut">
              <a:rPr lang="en-US" smtClean="0"/>
              <a:t>3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EDA898-FADA-427E-B551-B801CD8E8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90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9179748" y="1203176"/>
          <a:ext cx="5232686" cy="4003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4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179748" y="1203176"/>
                        <a:ext cx="5232686" cy="4003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8036430" y="2825788"/>
            <a:ext cx="27238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omerular filtration rate,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l/min/100g BW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017627" y="4584908"/>
            <a:ext cx="8433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902164" y="4584908"/>
            <a:ext cx="12202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robeneci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135005" y="138097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4987789" y="2899831"/>
            <a:ext cx="27238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omerular filtration rate,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l/min/100g BW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/>
          </p:nvPr>
        </p:nvGraphicFramePr>
        <p:xfrm>
          <a:off x="6242015" y="1203176"/>
          <a:ext cx="5232686" cy="4003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5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42015" y="1203176"/>
                        <a:ext cx="5232686" cy="4003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7056366" y="4584907"/>
            <a:ext cx="8433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940903" y="4584907"/>
            <a:ext cx="12202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robeneci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Object 17"/>
          <p:cNvGraphicFramePr>
            <a:graphicFrameLocks noChangeAspect="1"/>
          </p:cNvGraphicFramePr>
          <p:nvPr>
            <p:extLst/>
          </p:nvPr>
        </p:nvGraphicFramePr>
        <p:xfrm>
          <a:off x="3076957" y="1203176"/>
          <a:ext cx="5232686" cy="4003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6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76957" y="1203176"/>
                        <a:ext cx="5232686" cy="4003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F90D5FFC-A1A3-4E96-ABDE-05DFA9CC9B7A}"/>
              </a:ext>
            </a:extLst>
          </p:cNvPr>
          <p:cNvSpPr txBox="1"/>
          <p:nvPr/>
        </p:nvSpPr>
        <p:spPr>
          <a:xfrm rot="16200000">
            <a:off x="2227647" y="2757956"/>
            <a:ext cx="22218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kidneys/total body weight,%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867645" y="4584907"/>
            <a:ext cx="8433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752182" y="4584907"/>
            <a:ext cx="12202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robeneci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74199EC0-164D-4E6D-A526-1CE0FDA9E25E}"/>
              </a:ext>
            </a:extLst>
          </p:cNvPr>
          <p:cNvSpPr txBox="1"/>
          <p:nvPr/>
        </p:nvSpPr>
        <p:spPr>
          <a:xfrm rot="16200000">
            <a:off x="-690719" y="3135015"/>
            <a:ext cx="2530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yst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rea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% total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lic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211157" y="1221017"/>
          <a:ext cx="5232686" cy="4003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77" name="Graph" r:id="rId9" imgW="3920760" imgH="3000960" progId="Origin50.Graph">
                  <p:embed/>
                </p:oleObj>
              </mc:Choice>
              <mc:Fallback>
                <p:oleObj name="Graph" r:id="rId9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1157" y="1221017"/>
                        <a:ext cx="5232686" cy="4003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975381" y="4584907"/>
            <a:ext cx="8433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59918" y="4584907"/>
            <a:ext cx="12202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robeneci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35269" y="139330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072738" y="13869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098419" y="13757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11157" y="5689373"/>
            <a:ext cx="1204750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Lack of effect of probenecid in 12 months old female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Pkd1</a:t>
            </a:r>
            <a:r>
              <a:rPr lang="en-US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C/R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mice. No difference was found in cyst area (A), kidney hypertrophy (B), or glomerular filtration rate (C). D - Additional experiment shows no effect of probenecid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 GFR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in mal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57Bl/6N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ice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642070" y="5067527"/>
            <a:ext cx="14334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♀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Pkd1</a:t>
            </a:r>
            <a:r>
              <a:rPr lang="en-US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C/RC</a:t>
            </a:r>
            <a:endParaRPr lang="en-US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1212758" y="5051947"/>
            <a:ext cx="77434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Rectangle 23"/>
          <p:cNvSpPr/>
          <p:nvPr/>
        </p:nvSpPr>
        <p:spPr>
          <a:xfrm>
            <a:off x="10442128" y="5049340"/>
            <a:ext cx="14093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♂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57Bl/6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9351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81</TotalTime>
  <Words>93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Graph</vt:lpstr>
      <vt:lpstr>PowerPoint Presentation</vt:lpstr>
    </vt:vector>
  </TitlesOfParts>
  <Company>HF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lov, Tengis</dc:creator>
  <cp:lastModifiedBy>Pavlov, Tengis</cp:lastModifiedBy>
  <cp:revision>235</cp:revision>
  <cp:lastPrinted>2022-11-30T15:40:23Z</cp:lastPrinted>
  <dcterms:created xsi:type="dcterms:W3CDTF">2021-03-26T14:03:45Z</dcterms:created>
  <dcterms:modified xsi:type="dcterms:W3CDTF">2023-03-13T14:37:33Z</dcterms:modified>
</cp:coreProperties>
</file>